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6" y="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3A2A23-1629-BEBA-F28A-E2AC99377F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4840990-77D1-CB47-B256-1007076C93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D88D80-CFB4-F109-81B5-F35A6FBCD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020975-E124-9159-3F37-6D74CEA98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204D05A-EFF9-F6F9-9B25-07FE153FE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534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01C793-4ABA-AD3F-41A5-79C31311C2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1F5953A-372B-2664-D885-8DED734DF8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668C0F-1292-64BB-65E7-D4AC6BF87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E4BA60-386D-B4C6-6064-2E8BEF110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46F6B80-3F61-A23B-DBF5-1E2A40B03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0675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BDECC56-CF03-43A6-A975-14BC7767D2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E1001FA-3703-AA91-A595-1CC418D905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4D00D6-7A11-88F4-DE8E-A896FCD4A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9EF1F5-957F-7C6E-B299-33EC38D20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7F6F70-9C4C-8BB0-FEF7-8E9A1B0A3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962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F8F1AB-0EBC-E884-2A60-5CFA9D2F4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B58D551-5E21-5868-B240-9D132E2901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1E0D06-7BCC-5BA4-6652-8406A2386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B022E7-4164-F2C2-355E-BDC3718BA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E28717-5C68-7CE4-B07B-A047F308C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602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7416AE-0249-B6EF-4540-E6FF632A9C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DD169F3-F2DF-0B9F-7E68-C4988CA758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A37604-1E08-7B85-1B8F-7F2D2F6D9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CD3601-FCF8-81BF-A744-39735F6BD7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32501E3-C2F9-4194-C75E-9BBACB3C3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675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E9FF79-144C-1786-86D4-E0EEA24387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3BE2849-BDB5-C222-2916-C780DAF557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06CBB4C-B9E8-043C-0153-4DE204F81A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9260DF-828C-8916-8E85-E9027630AB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3A83578-DCCA-5A32-5CB9-6E1DF19F8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E250729-A914-920F-C3F1-295C7FB87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769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1F3971-FF07-EB56-E00B-F9312F4F42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76A36CB-7D52-832D-D7F2-AB0EC28975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9B8310B-BF23-6816-2EC9-8269E61CFC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041813E-EFA5-D2AF-3BE5-CC28D0740D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D3BDC5B-C62A-67E4-31FB-0F1E8B3C81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D1837BE-87A1-BF3D-E503-DA7FBA71C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4F75E04-1F44-C5B1-E56B-ADFB37F58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DCB60B2-557F-3A8D-E489-51D2F928A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6095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90CBA7-3B0A-9185-6106-80424F27E4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FB30376-8E40-F3E3-31E3-10A1DE6C2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A20C5DA-B8B5-16F5-8CF8-FF6F43852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DB34D42-C89D-5395-E7A8-261AB973B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8177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AAF586A-961B-FB49-0E5E-B8461A9A1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C6F8418-1B09-BB23-AF5B-9A68A045A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C6AF8A0-2DE6-1763-0DAE-B54888CF1A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8134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27045B-6C90-1042-2AE1-AC1DB352D5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B01A538-EB4F-1AB4-A366-138D5C5C52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6C2DB25-A24A-220E-131B-9BA29D69B9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13E0EF6-2B09-B0CC-83CD-9F21BF875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B3BC4CB-F133-2509-2DDF-692CAE90F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537E043-8B2A-52FA-A055-FD028A3D5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8526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EDD044-4608-29C1-1063-C79F801F6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72A11F4-5911-182A-7E72-256C58A0DE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D67529C-809D-11CC-D0E2-CFDD9E4EA4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52A7B26-240B-2E18-DFB7-DDE06F9CF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478183-5BD2-9A11-8FC0-E85488B8D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AF90C3E-D552-1F9D-D27E-E8D8DB567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677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4E5D651-3680-4A54-BA39-0F14301E72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81DDFAA-27AC-F9B7-EF8A-FE87E3381C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6D70D0-77EE-62CF-7484-B93096D1E9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A0D54-591D-4001-A940-4B8D22630369}" type="datetimeFigureOut">
              <a:rPr kumimoji="1" lang="ja-JP" altLang="en-US" smtClean="0"/>
              <a:t>2025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E07209-0464-65CA-939B-33EB1D8C22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B12BC1-5E48-C687-D162-7AA49E7436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E93059-3E76-430B-ADB8-1C4E849F86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7252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F40359E5-3AAE-74AD-E7EE-AE211D5C8C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98" t="7830" r="5694" b="25549"/>
          <a:stretch>
            <a:fillRect/>
          </a:stretch>
        </p:blipFill>
        <p:spPr>
          <a:xfrm>
            <a:off x="226142" y="717756"/>
            <a:ext cx="3441290" cy="2595716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62EA1270-3743-7771-E1DE-2C8774BAE6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39" t="7831" r="5253" b="25549"/>
          <a:stretch>
            <a:fillRect/>
          </a:stretch>
        </p:blipFill>
        <p:spPr>
          <a:xfrm>
            <a:off x="3667432" y="717756"/>
            <a:ext cx="3441290" cy="2595716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355BDEB-F0CC-700B-6232-0CEC4BB919BB}"/>
              </a:ext>
            </a:extLst>
          </p:cNvPr>
          <p:cNvSpPr txBox="1"/>
          <p:nvPr/>
        </p:nvSpPr>
        <p:spPr>
          <a:xfrm>
            <a:off x="176981" y="98322"/>
            <a:ext cx="71972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S1.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Practical application of the Inoue balloon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C1C0179-002B-F5F5-F9F5-ACA703A261CE}"/>
              </a:ext>
            </a:extLst>
          </p:cNvPr>
          <p:cNvSpPr txBox="1"/>
          <p:nvPr/>
        </p:nvSpPr>
        <p:spPr>
          <a:xfrm>
            <a:off x="127820" y="717756"/>
            <a:ext cx="570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(A)</a:t>
            </a:r>
            <a:endParaRPr kumimoji="1" lang="ja-JP" altLang="en-US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9E5B10E-0E8B-F84D-B12B-1F62FBCE76CB}"/>
              </a:ext>
            </a:extLst>
          </p:cNvPr>
          <p:cNvSpPr txBox="1"/>
          <p:nvPr/>
        </p:nvSpPr>
        <p:spPr>
          <a:xfrm>
            <a:off x="3549446" y="717756"/>
            <a:ext cx="570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(B)</a:t>
            </a:r>
            <a:endParaRPr kumimoji="1" lang="ja-JP" altLang="en-US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7F5B749-E430-54DC-40EB-54CA35D72D00}"/>
              </a:ext>
            </a:extLst>
          </p:cNvPr>
          <p:cNvSpPr txBox="1"/>
          <p:nvPr/>
        </p:nvSpPr>
        <p:spPr>
          <a:xfrm>
            <a:off x="226142" y="3657600"/>
            <a:ext cx="7285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e-dilatation without rapid pacing: (A) Half inflation, (B) Full inflation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0067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圭祐 松尾</dc:creator>
  <cp:lastModifiedBy>Jessy Filice</cp:lastModifiedBy>
  <cp:revision>2</cp:revision>
  <dcterms:created xsi:type="dcterms:W3CDTF">2025-08-09T09:32:39Z</dcterms:created>
  <dcterms:modified xsi:type="dcterms:W3CDTF">2025-08-22T16:26:24Z</dcterms:modified>
</cp:coreProperties>
</file>